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954" y="27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0BB6C29-4578-44D6-901F-E6DF541EDEF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9BC6DEEC-A7D2-4FE6-B3FA-AD894526431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DF7E962-4A75-4854-89C4-CEB6A24F27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9F5D9-E5F5-4AB9-B661-08853E3DC8EA}" type="datetimeFigureOut">
              <a:rPr lang="de-DE" smtClean="0"/>
              <a:t>16.09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E124A21-B856-49A0-A603-1A2A950D2E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CF56B8C-ED7A-4948-9089-E8F412156E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54EDE-8A52-4C97-BC61-FB8F2A11E3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073887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ED7D70F-BD10-4B8E-B126-1FE4EB88D4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26160963-9273-433A-AF3B-9A2DC1E5813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25C182B-E281-4A61-AABC-8700430B12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9F5D9-E5F5-4AB9-B661-08853E3DC8EA}" type="datetimeFigureOut">
              <a:rPr lang="de-DE" smtClean="0"/>
              <a:t>16.09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1CDF931-2F2C-439D-856D-1DB64E9054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E26EA83-C90C-4C59-8D53-4431936BAC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54EDE-8A52-4C97-BC61-FB8F2A11E3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078192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3C19614D-7749-4A6E-9DD5-0ED449D19A4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40101730-0699-44A4-8496-535305B8C59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6F65CBB-77EE-4B11-9C45-BF19D4D438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9F5D9-E5F5-4AB9-B661-08853E3DC8EA}" type="datetimeFigureOut">
              <a:rPr lang="de-DE" smtClean="0"/>
              <a:t>16.09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506490D-A111-4C62-93E6-B5D212A9DE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165C1C0-5C0D-4337-8A71-BE9D44F579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54EDE-8A52-4C97-BC61-FB8F2A11E3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5907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5571D18-7937-4866-9752-22CB8D0E74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4F8FC1B0-72BF-42EB-B313-3E25963E1F5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A204E2F-1CCC-4C83-B8B2-C553337568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9F5D9-E5F5-4AB9-B661-08853E3DC8EA}" type="datetimeFigureOut">
              <a:rPr lang="de-DE" smtClean="0"/>
              <a:t>16.09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63AF81B-B7DC-412A-8F2F-C2749E2DFF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1BB8AA7-D7FE-4D7D-838B-8614DE0A3F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54EDE-8A52-4C97-BC61-FB8F2A11E3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953537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3315F71-ABA2-4F96-BC99-6C20468346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D636E4CA-4974-4799-92A7-A7CF14C920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5F3CEB0-6EA5-44DC-A458-4DEE843CE1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9F5D9-E5F5-4AB9-B661-08853E3DC8EA}" type="datetimeFigureOut">
              <a:rPr lang="de-DE" smtClean="0"/>
              <a:t>16.09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EC61309-F78F-412F-96A7-80460C3569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44C895D-8DC0-4DC3-9DD2-0445A77308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54EDE-8A52-4C97-BC61-FB8F2A11E3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951115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D820509-1C99-4400-9B54-084CEC6BBE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67BC9A6D-24F4-4366-AF85-64B2AD2F70F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C4337A71-CD6A-430F-8FF3-297C944516F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6B9ED712-055F-4096-935E-84C81895BC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9F5D9-E5F5-4AB9-B661-08853E3DC8EA}" type="datetimeFigureOut">
              <a:rPr lang="de-DE" smtClean="0"/>
              <a:t>16.09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034223CF-151C-4FDE-AC1C-CB7BEEFA44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E70875C9-1096-4559-8395-04424DB650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54EDE-8A52-4C97-BC61-FB8F2A11E3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346120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2045E25-B36E-41F4-A58D-E6E3294FFB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6707B87A-DF62-4564-A4CE-2D47A24F9D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AA8EB1D7-430A-47D4-9029-D126DA0672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F311AA6A-7941-4402-867F-0651E1A431C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8EA35DB7-4ADE-4A3B-90E8-7ED0B2AAA3A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6D88DC09-1EEF-4907-94C2-0C2468224F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9F5D9-E5F5-4AB9-B661-08853E3DC8EA}" type="datetimeFigureOut">
              <a:rPr lang="de-DE" smtClean="0"/>
              <a:t>16.09.2023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3E5B2EC9-1FA6-4A08-9DE7-D771ABA8B5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560873E6-64ED-4FB9-88E3-4CC4D0FFAF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54EDE-8A52-4C97-BC61-FB8F2A11E3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198431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971D3C2-BD29-459D-B8AC-846FD5FDFC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231404B4-A0DA-40E4-B3BD-66932551AD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9F5D9-E5F5-4AB9-B661-08853E3DC8EA}" type="datetimeFigureOut">
              <a:rPr lang="de-DE" smtClean="0"/>
              <a:t>16.09.2023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34A09139-6655-4CCD-8C43-11E3F37D39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FFEF65FF-3B41-4E01-831B-15F8C4EA10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54EDE-8A52-4C97-BC61-FB8F2A11E3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926143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4332D855-B5F2-4078-A26B-A19B42FA33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9F5D9-E5F5-4AB9-B661-08853E3DC8EA}" type="datetimeFigureOut">
              <a:rPr lang="de-DE" smtClean="0"/>
              <a:t>16.09.2023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C2BC2151-B05F-454E-B384-22493CE9F6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E1033EC2-8C5D-4B09-AB15-B9DD63CA60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54EDE-8A52-4C97-BC61-FB8F2A11E3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865624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0F36CFF-9EC7-49B1-9A3E-B1E66C4861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7008D01F-7C16-429A-AC2E-B286B0C4D05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87157B73-2D8E-4A35-A713-84397D74BB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C573A56E-3E9E-47F4-9F5A-A85D973371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9F5D9-E5F5-4AB9-B661-08853E3DC8EA}" type="datetimeFigureOut">
              <a:rPr lang="de-DE" smtClean="0"/>
              <a:t>16.09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C84E7CDE-7DBF-4B0D-8A83-96ACB98412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F1026D68-C875-4A01-9C76-CCB2F6482C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54EDE-8A52-4C97-BC61-FB8F2A11E3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826913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D17884C-707F-4566-B7FD-5B0778C3D0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78164B17-DE83-4CD0-B303-1B8FA97769C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8CAB2061-8F9A-42D2-8551-B780B06DB6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181F3C77-3999-4CF9-9DE7-068D16CCBC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9F5D9-E5F5-4AB9-B661-08853E3DC8EA}" type="datetimeFigureOut">
              <a:rPr lang="de-DE" smtClean="0"/>
              <a:t>16.09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9DABDE00-E491-4E5D-859E-0F5F697F15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7BBD81E7-73C9-4767-B222-39FC8B1BFA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54EDE-8A52-4C97-BC61-FB8F2A11E3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949121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A62BDCB6-EE18-40FF-A8BC-1FA29F631D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19540919-0BF3-442B-AB54-740DCD7929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890BD82-84D0-42F9-A4DC-B8976FA549D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B9F5D9-E5F5-4AB9-B661-08853E3DC8EA}" type="datetimeFigureOut">
              <a:rPr lang="de-DE" smtClean="0"/>
              <a:t>16.09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3C2C70D-F1E1-46A8-BFF6-EBF11F59F08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2D4D52D-4AC0-4505-A3FA-4BD42ED0E2D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C54EDE-8A52-4C97-BC61-FB8F2A11E3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905842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>
            <a:extLst>
              <a:ext uri="{FF2B5EF4-FFF2-40B4-BE49-F238E27FC236}">
                <a16:creationId xmlns:a16="http://schemas.microsoft.com/office/drawing/2014/main" id="{71288460-D44A-4174-BD5F-00775A43F3E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128" b="18854"/>
          <a:stretch/>
        </p:blipFill>
        <p:spPr>
          <a:xfrm>
            <a:off x="675154" y="568171"/>
            <a:ext cx="5043642" cy="2816713"/>
          </a:xfrm>
          <a:prstGeom prst="rect">
            <a:avLst/>
          </a:prstGeom>
          <a:ln>
            <a:noFill/>
          </a:ln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1C24DA7A-5408-44D6-B1E1-22719351072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449" b="19702"/>
          <a:stretch/>
        </p:blipFill>
        <p:spPr>
          <a:xfrm>
            <a:off x="672639" y="3488504"/>
            <a:ext cx="5046157" cy="2952738"/>
          </a:xfrm>
          <a:prstGeom prst="rect">
            <a:avLst/>
          </a:prstGeom>
          <a:ln>
            <a:noFill/>
          </a:ln>
        </p:spPr>
      </p:pic>
      <p:sp>
        <p:nvSpPr>
          <p:cNvPr id="8" name="Textfeld 7">
            <a:extLst>
              <a:ext uri="{FF2B5EF4-FFF2-40B4-BE49-F238E27FC236}">
                <a16:creationId xmlns:a16="http://schemas.microsoft.com/office/drawing/2014/main" id="{D0A4A26A-5405-4A9A-91C7-78A6FEA85FA0}"/>
              </a:ext>
            </a:extLst>
          </p:cNvPr>
          <p:cNvSpPr txBox="1"/>
          <p:nvPr/>
        </p:nvSpPr>
        <p:spPr>
          <a:xfrm>
            <a:off x="5716285" y="1630492"/>
            <a:ext cx="8444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>
                <a:solidFill>
                  <a:srgbClr val="FF0000"/>
                </a:solidFill>
              </a:rPr>
              <a:t>GAPDH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CE867FDC-9D90-4EE7-BCE9-36B5E4A0D7AC}"/>
              </a:ext>
            </a:extLst>
          </p:cNvPr>
          <p:cNvSpPr txBox="1"/>
          <p:nvPr/>
        </p:nvSpPr>
        <p:spPr>
          <a:xfrm>
            <a:off x="107581" y="1668889"/>
            <a:ext cx="5675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/>
              <a:t>32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C09A3657-CB27-4787-89F0-C9D4058409DF}"/>
              </a:ext>
            </a:extLst>
          </p:cNvPr>
          <p:cNvSpPr txBox="1"/>
          <p:nvPr/>
        </p:nvSpPr>
        <p:spPr>
          <a:xfrm>
            <a:off x="114343" y="1522471"/>
            <a:ext cx="5675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/>
              <a:t>42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025AF30B-B5B7-49FF-9B3B-57A86ABF7A3D}"/>
              </a:ext>
            </a:extLst>
          </p:cNvPr>
          <p:cNvSpPr txBox="1"/>
          <p:nvPr/>
        </p:nvSpPr>
        <p:spPr>
          <a:xfrm rot="18900000">
            <a:off x="4399492" y="264054"/>
            <a:ext cx="5783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Tor2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710C2F2B-3F0C-4B70-82DA-B745402CFF95}"/>
              </a:ext>
            </a:extLst>
          </p:cNvPr>
          <p:cNvSpPr txBox="1"/>
          <p:nvPr/>
        </p:nvSpPr>
        <p:spPr>
          <a:xfrm rot="18900000">
            <a:off x="4169296" y="202272"/>
            <a:ext cx="7530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Wuhan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6CA3D8D2-8522-4D04-B9FE-C0ABD989ABCC}"/>
              </a:ext>
            </a:extLst>
          </p:cNvPr>
          <p:cNvSpPr txBox="1"/>
          <p:nvPr/>
        </p:nvSpPr>
        <p:spPr>
          <a:xfrm rot="18900000">
            <a:off x="3915380" y="191780"/>
            <a:ext cx="78273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BANAL20-52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5D6E23DE-76FD-4B68-AF1B-3176EC53DC06}"/>
              </a:ext>
            </a:extLst>
          </p:cNvPr>
          <p:cNvSpPr txBox="1"/>
          <p:nvPr/>
        </p:nvSpPr>
        <p:spPr>
          <a:xfrm rot="18900000">
            <a:off x="3697259" y="227812"/>
            <a:ext cx="68082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ZXC21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04C202B4-173C-449F-B0E7-19675942BD23}"/>
              </a:ext>
            </a:extLst>
          </p:cNvPr>
          <p:cNvSpPr txBox="1"/>
          <p:nvPr/>
        </p:nvSpPr>
        <p:spPr>
          <a:xfrm rot="18900000">
            <a:off x="3438606" y="208160"/>
            <a:ext cx="73641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Tor2</a:t>
            </a: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56181717-D42B-4301-A55F-C13826974477}"/>
              </a:ext>
            </a:extLst>
          </p:cNvPr>
          <p:cNvSpPr txBox="1"/>
          <p:nvPr/>
        </p:nvSpPr>
        <p:spPr>
          <a:xfrm rot="18900000">
            <a:off x="3193805" y="156220"/>
            <a:ext cx="88331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Wuhan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F0ED450B-6B44-4589-BF91-2036466AC9AB}"/>
              </a:ext>
            </a:extLst>
          </p:cNvPr>
          <p:cNvSpPr txBox="1"/>
          <p:nvPr/>
        </p:nvSpPr>
        <p:spPr>
          <a:xfrm rot="18900000">
            <a:off x="2976717" y="191780"/>
            <a:ext cx="78273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BANAL20-52</a:t>
            </a: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3190AF73-3CB6-4406-B806-776D50656EB9}"/>
              </a:ext>
            </a:extLst>
          </p:cNvPr>
          <p:cNvSpPr txBox="1"/>
          <p:nvPr/>
        </p:nvSpPr>
        <p:spPr>
          <a:xfrm rot="18900000">
            <a:off x="2769685" y="213946"/>
            <a:ext cx="72004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ZXC21</a:t>
            </a: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B096447E-B649-4A2A-B775-930D3360F407}"/>
              </a:ext>
            </a:extLst>
          </p:cNvPr>
          <p:cNvSpPr txBox="1"/>
          <p:nvPr/>
        </p:nvSpPr>
        <p:spPr>
          <a:xfrm rot="18900000">
            <a:off x="2528973" y="199388"/>
            <a:ext cx="7612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Tor2</a:t>
            </a: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3977F44C-FD6C-43CF-9FE0-3D7E9214D274}"/>
              </a:ext>
            </a:extLst>
          </p:cNvPr>
          <p:cNvSpPr txBox="1"/>
          <p:nvPr/>
        </p:nvSpPr>
        <p:spPr>
          <a:xfrm rot="18900000">
            <a:off x="2267156" y="189868"/>
            <a:ext cx="7881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Wuhan</a:t>
            </a: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25522B0A-BCFB-4B1B-8DDF-26D37561A498}"/>
              </a:ext>
            </a:extLst>
          </p:cNvPr>
          <p:cNvSpPr txBox="1"/>
          <p:nvPr/>
        </p:nvSpPr>
        <p:spPr>
          <a:xfrm rot="18900000">
            <a:off x="2040850" y="191780"/>
            <a:ext cx="78273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BANAL20-52</a:t>
            </a: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57265A64-F960-4497-B6DA-24764D9ED90A}"/>
              </a:ext>
            </a:extLst>
          </p:cNvPr>
          <p:cNvSpPr txBox="1"/>
          <p:nvPr/>
        </p:nvSpPr>
        <p:spPr>
          <a:xfrm rot="18900000">
            <a:off x="1865905" y="267749"/>
            <a:ext cx="56786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ZXC21</a:t>
            </a: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1622FFAC-1530-417B-A7B6-66AC24193C02}"/>
              </a:ext>
            </a:extLst>
          </p:cNvPr>
          <p:cNvSpPr txBox="1"/>
          <p:nvPr/>
        </p:nvSpPr>
        <p:spPr>
          <a:xfrm rot="18900000">
            <a:off x="1591780" y="197133"/>
            <a:ext cx="7675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Tor2</a:t>
            </a: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A54405DD-806F-42EF-8B67-D976E37E0F55}"/>
              </a:ext>
            </a:extLst>
          </p:cNvPr>
          <p:cNvSpPr txBox="1"/>
          <p:nvPr/>
        </p:nvSpPr>
        <p:spPr>
          <a:xfrm rot="18900000">
            <a:off x="1368001" y="172265"/>
            <a:ext cx="8379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Wuhan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B0636699-E146-4B39-A7B5-EFD3F7178C19}"/>
              </a:ext>
            </a:extLst>
          </p:cNvPr>
          <p:cNvSpPr txBox="1"/>
          <p:nvPr/>
        </p:nvSpPr>
        <p:spPr>
          <a:xfrm rot="18900000">
            <a:off x="1131873" y="191780"/>
            <a:ext cx="78273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BANAL20-52</a:t>
            </a: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F49FD0F5-5828-4A6A-B45D-3FC6F5B9AAEB}"/>
              </a:ext>
            </a:extLst>
          </p:cNvPr>
          <p:cNvSpPr txBox="1"/>
          <p:nvPr/>
        </p:nvSpPr>
        <p:spPr>
          <a:xfrm rot="18900000">
            <a:off x="907465" y="192314"/>
            <a:ext cx="78122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ZXC21</a:t>
            </a:r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C3D10509-68E0-4F81-A877-7EF69C08CDDC}"/>
              </a:ext>
            </a:extLst>
          </p:cNvPr>
          <p:cNvSpPr txBox="1"/>
          <p:nvPr/>
        </p:nvSpPr>
        <p:spPr>
          <a:xfrm>
            <a:off x="4016674" y="6449110"/>
            <a:ext cx="4950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2µg</a:t>
            </a:r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id="{3EB5A184-28E0-49A2-948F-FBC92083983E}"/>
              </a:ext>
            </a:extLst>
          </p:cNvPr>
          <p:cNvSpPr txBox="1"/>
          <p:nvPr/>
        </p:nvSpPr>
        <p:spPr>
          <a:xfrm>
            <a:off x="3095412" y="6449111"/>
            <a:ext cx="4950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1µg</a:t>
            </a:r>
          </a:p>
        </p:txBody>
      </p:sp>
      <p:sp>
        <p:nvSpPr>
          <p:cNvPr id="35" name="Textfeld 34">
            <a:extLst>
              <a:ext uri="{FF2B5EF4-FFF2-40B4-BE49-F238E27FC236}">
                <a16:creationId xmlns:a16="http://schemas.microsoft.com/office/drawing/2014/main" id="{50F21005-572A-4DD1-B461-D77EA7061B01}"/>
              </a:ext>
            </a:extLst>
          </p:cNvPr>
          <p:cNvSpPr txBox="1"/>
          <p:nvPr/>
        </p:nvSpPr>
        <p:spPr>
          <a:xfrm>
            <a:off x="2140708" y="6449111"/>
            <a:ext cx="6498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0,5µg</a:t>
            </a:r>
          </a:p>
        </p:txBody>
      </p:sp>
      <p:sp>
        <p:nvSpPr>
          <p:cNvPr id="36" name="Textfeld 35">
            <a:extLst>
              <a:ext uri="{FF2B5EF4-FFF2-40B4-BE49-F238E27FC236}">
                <a16:creationId xmlns:a16="http://schemas.microsoft.com/office/drawing/2014/main" id="{E1A5B44D-EDD0-4D47-8603-178B321DF504}"/>
              </a:ext>
            </a:extLst>
          </p:cNvPr>
          <p:cNvSpPr txBox="1"/>
          <p:nvPr/>
        </p:nvSpPr>
        <p:spPr>
          <a:xfrm>
            <a:off x="1177910" y="6449111"/>
            <a:ext cx="7535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0,25µg</a:t>
            </a:r>
          </a:p>
        </p:txBody>
      </p:sp>
      <p:cxnSp>
        <p:nvCxnSpPr>
          <p:cNvPr id="38" name="Gerader Verbinder 37">
            <a:extLst>
              <a:ext uri="{FF2B5EF4-FFF2-40B4-BE49-F238E27FC236}">
                <a16:creationId xmlns:a16="http://schemas.microsoft.com/office/drawing/2014/main" id="{9D7C9CE0-BD44-4352-88BF-025053FC193C}"/>
              </a:ext>
            </a:extLst>
          </p:cNvPr>
          <p:cNvCxnSpPr>
            <a:cxnSpLocks/>
          </p:cNvCxnSpPr>
          <p:nvPr/>
        </p:nvCxnSpPr>
        <p:spPr>
          <a:xfrm>
            <a:off x="1121938" y="6476629"/>
            <a:ext cx="86554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feld 41">
            <a:extLst>
              <a:ext uri="{FF2B5EF4-FFF2-40B4-BE49-F238E27FC236}">
                <a16:creationId xmlns:a16="http://schemas.microsoft.com/office/drawing/2014/main" id="{AEF87F9E-6CFB-4DF3-965B-79D2B72ACDBB}"/>
              </a:ext>
            </a:extLst>
          </p:cNvPr>
          <p:cNvSpPr txBox="1"/>
          <p:nvPr/>
        </p:nvSpPr>
        <p:spPr>
          <a:xfrm>
            <a:off x="291612" y="326051"/>
            <a:ext cx="4430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/>
              <a:t>kDa</a:t>
            </a:r>
            <a:endParaRPr lang="de-DE" sz="1200" dirty="0"/>
          </a:p>
        </p:txBody>
      </p:sp>
      <p:sp>
        <p:nvSpPr>
          <p:cNvPr id="43" name="Textfeld 42">
            <a:extLst>
              <a:ext uri="{FF2B5EF4-FFF2-40B4-BE49-F238E27FC236}">
                <a16:creationId xmlns:a16="http://schemas.microsoft.com/office/drawing/2014/main" id="{8F28B6E1-399B-4D96-9E4F-0A0105FC7E77}"/>
              </a:ext>
            </a:extLst>
          </p:cNvPr>
          <p:cNvSpPr txBox="1"/>
          <p:nvPr/>
        </p:nvSpPr>
        <p:spPr>
          <a:xfrm>
            <a:off x="5721355" y="5179883"/>
            <a:ext cx="8444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>
                <a:solidFill>
                  <a:srgbClr val="FF0000"/>
                </a:solidFill>
              </a:rPr>
              <a:t>HA</a:t>
            </a:r>
          </a:p>
        </p:txBody>
      </p:sp>
      <p:sp>
        <p:nvSpPr>
          <p:cNvPr id="37" name="Rechteck 36">
            <a:extLst>
              <a:ext uri="{FF2B5EF4-FFF2-40B4-BE49-F238E27FC236}">
                <a16:creationId xmlns:a16="http://schemas.microsoft.com/office/drawing/2014/main" id="{9FDB7814-577D-497E-9C85-DE53EA751B1D}"/>
              </a:ext>
            </a:extLst>
          </p:cNvPr>
          <p:cNvSpPr/>
          <p:nvPr/>
        </p:nvSpPr>
        <p:spPr>
          <a:xfrm>
            <a:off x="686279" y="1630492"/>
            <a:ext cx="1195315" cy="33855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4" name="Rechteck 43">
            <a:extLst>
              <a:ext uri="{FF2B5EF4-FFF2-40B4-BE49-F238E27FC236}">
                <a16:creationId xmlns:a16="http://schemas.microsoft.com/office/drawing/2014/main" id="{EF6BD602-39E3-4709-820F-BE278C181237}"/>
              </a:ext>
            </a:extLst>
          </p:cNvPr>
          <p:cNvSpPr/>
          <p:nvPr/>
        </p:nvSpPr>
        <p:spPr>
          <a:xfrm>
            <a:off x="1887956" y="1634927"/>
            <a:ext cx="932599" cy="33855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5" name="Rechteck 44">
            <a:extLst>
              <a:ext uri="{FF2B5EF4-FFF2-40B4-BE49-F238E27FC236}">
                <a16:creationId xmlns:a16="http://schemas.microsoft.com/office/drawing/2014/main" id="{F0AEA5A0-1F26-4F72-82D6-EC9BFDE4B90A}"/>
              </a:ext>
            </a:extLst>
          </p:cNvPr>
          <p:cNvSpPr/>
          <p:nvPr/>
        </p:nvSpPr>
        <p:spPr>
          <a:xfrm>
            <a:off x="2826918" y="1630492"/>
            <a:ext cx="932600" cy="33855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6" name="Rechteck 45">
            <a:extLst>
              <a:ext uri="{FF2B5EF4-FFF2-40B4-BE49-F238E27FC236}">
                <a16:creationId xmlns:a16="http://schemas.microsoft.com/office/drawing/2014/main" id="{5FEC4D5D-7F99-4DC9-B0A7-AA6F8EA7EAF3}"/>
              </a:ext>
            </a:extLst>
          </p:cNvPr>
          <p:cNvSpPr/>
          <p:nvPr/>
        </p:nvSpPr>
        <p:spPr>
          <a:xfrm>
            <a:off x="3760523" y="1630492"/>
            <a:ext cx="932600" cy="33855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7" name="Rechteck 46">
            <a:extLst>
              <a:ext uri="{FF2B5EF4-FFF2-40B4-BE49-F238E27FC236}">
                <a16:creationId xmlns:a16="http://schemas.microsoft.com/office/drawing/2014/main" id="{457F74CC-5190-41FE-9E6E-D42CFA3EEBDB}"/>
              </a:ext>
            </a:extLst>
          </p:cNvPr>
          <p:cNvSpPr/>
          <p:nvPr/>
        </p:nvSpPr>
        <p:spPr>
          <a:xfrm>
            <a:off x="711350" y="5164669"/>
            <a:ext cx="1195315" cy="33855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8" name="Rechteck 47">
            <a:extLst>
              <a:ext uri="{FF2B5EF4-FFF2-40B4-BE49-F238E27FC236}">
                <a16:creationId xmlns:a16="http://schemas.microsoft.com/office/drawing/2014/main" id="{BADC2C41-3A6E-4D5B-849F-77BC9D2E91CF}"/>
              </a:ext>
            </a:extLst>
          </p:cNvPr>
          <p:cNvSpPr/>
          <p:nvPr/>
        </p:nvSpPr>
        <p:spPr>
          <a:xfrm>
            <a:off x="1913027" y="5169104"/>
            <a:ext cx="932599" cy="33855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9" name="Rechteck 48">
            <a:extLst>
              <a:ext uri="{FF2B5EF4-FFF2-40B4-BE49-F238E27FC236}">
                <a16:creationId xmlns:a16="http://schemas.microsoft.com/office/drawing/2014/main" id="{C5A9D4D0-6F76-4E88-987F-2D028C966196}"/>
              </a:ext>
            </a:extLst>
          </p:cNvPr>
          <p:cNvSpPr/>
          <p:nvPr/>
        </p:nvSpPr>
        <p:spPr>
          <a:xfrm>
            <a:off x="2843111" y="5164669"/>
            <a:ext cx="932600" cy="33855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0" name="Rechteck 49">
            <a:extLst>
              <a:ext uri="{FF2B5EF4-FFF2-40B4-BE49-F238E27FC236}">
                <a16:creationId xmlns:a16="http://schemas.microsoft.com/office/drawing/2014/main" id="{90B14CD0-09A3-4AE9-99B6-5D6CAF39C54E}"/>
              </a:ext>
            </a:extLst>
          </p:cNvPr>
          <p:cNvSpPr/>
          <p:nvPr/>
        </p:nvSpPr>
        <p:spPr>
          <a:xfrm>
            <a:off x="3776716" y="5164669"/>
            <a:ext cx="932600" cy="33855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1" name="Textfeld 50">
            <a:extLst>
              <a:ext uri="{FF2B5EF4-FFF2-40B4-BE49-F238E27FC236}">
                <a16:creationId xmlns:a16="http://schemas.microsoft.com/office/drawing/2014/main" id="{9A394FD3-2179-4B0C-905D-445B8AD9D85D}"/>
              </a:ext>
            </a:extLst>
          </p:cNvPr>
          <p:cNvSpPr txBox="1"/>
          <p:nvPr/>
        </p:nvSpPr>
        <p:spPr>
          <a:xfrm>
            <a:off x="112023" y="5097807"/>
            <a:ext cx="5675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/>
              <a:t>8</a:t>
            </a:r>
          </a:p>
        </p:txBody>
      </p:sp>
      <p:cxnSp>
        <p:nvCxnSpPr>
          <p:cNvPr id="53" name="Gerader Verbinder 52">
            <a:extLst>
              <a:ext uri="{FF2B5EF4-FFF2-40B4-BE49-F238E27FC236}">
                <a16:creationId xmlns:a16="http://schemas.microsoft.com/office/drawing/2014/main" id="{1C7D653A-899F-4FA1-BC3B-D9CE77C9B2B3}"/>
              </a:ext>
            </a:extLst>
          </p:cNvPr>
          <p:cNvCxnSpPr>
            <a:cxnSpLocks/>
          </p:cNvCxnSpPr>
          <p:nvPr/>
        </p:nvCxnSpPr>
        <p:spPr>
          <a:xfrm>
            <a:off x="2032869" y="6476629"/>
            <a:ext cx="86554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Gerader Verbinder 53">
            <a:extLst>
              <a:ext uri="{FF2B5EF4-FFF2-40B4-BE49-F238E27FC236}">
                <a16:creationId xmlns:a16="http://schemas.microsoft.com/office/drawing/2014/main" id="{F04FEA3C-BDD5-49D9-8C8F-C8401B3BD570}"/>
              </a:ext>
            </a:extLst>
          </p:cNvPr>
          <p:cNvCxnSpPr>
            <a:cxnSpLocks/>
          </p:cNvCxnSpPr>
          <p:nvPr/>
        </p:nvCxnSpPr>
        <p:spPr>
          <a:xfrm>
            <a:off x="2910170" y="6476629"/>
            <a:ext cx="86554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Gerader Verbinder 54">
            <a:extLst>
              <a:ext uri="{FF2B5EF4-FFF2-40B4-BE49-F238E27FC236}">
                <a16:creationId xmlns:a16="http://schemas.microsoft.com/office/drawing/2014/main" id="{06E1AFE4-1179-45FA-B019-2FE89753DE08}"/>
              </a:ext>
            </a:extLst>
          </p:cNvPr>
          <p:cNvCxnSpPr>
            <a:cxnSpLocks/>
          </p:cNvCxnSpPr>
          <p:nvPr/>
        </p:nvCxnSpPr>
        <p:spPr>
          <a:xfrm>
            <a:off x="3831432" y="6476629"/>
            <a:ext cx="86554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feld 55">
            <a:extLst>
              <a:ext uri="{FF2B5EF4-FFF2-40B4-BE49-F238E27FC236}">
                <a16:creationId xmlns:a16="http://schemas.microsoft.com/office/drawing/2014/main" id="{D723CB08-45C1-42E8-A7C9-D53C8446EE4D}"/>
              </a:ext>
            </a:extLst>
          </p:cNvPr>
          <p:cNvSpPr txBox="1"/>
          <p:nvPr/>
        </p:nvSpPr>
        <p:spPr>
          <a:xfrm>
            <a:off x="291611" y="3269756"/>
            <a:ext cx="4430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/>
              <a:t>kDa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19382099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>
            <a:extLst>
              <a:ext uri="{FF2B5EF4-FFF2-40B4-BE49-F238E27FC236}">
                <a16:creationId xmlns:a16="http://schemas.microsoft.com/office/drawing/2014/main" id="{71288460-D44A-4174-BD5F-00775A43F3E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227" t="40000" r="57161" b="52062"/>
          <a:stretch/>
        </p:blipFill>
        <p:spPr>
          <a:xfrm>
            <a:off x="4762501" y="3076240"/>
            <a:ext cx="1035049" cy="37343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1C24DA7A-5408-44D6-B1E1-22719351072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216" t="51366" r="57181" b="40825"/>
          <a:stretch/>
        </p:blipFill>
        <p:spPr>
          <a:xfrm>
            <a:off x="4762501" y="3663934"/>
            <a:ext cx="1035049" cy="36927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7" name="Grafik 36">
            <a:extLst>
              <a:ext uri="{FF2B5EF4-FFF2-40B4-BE49-F238E27FC236}">
                <a16:creationId xmlns:a16="http://schemas.microsoft.com/office/drawing/2014/main" id="{D6E6A040-0ABD-4033-B0C1-652961077C3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0000" r="75773" b="52062"/>
          <a:stretch/>
        </p:blipFill>
        <p:spPr>
          <a:xfrm>
            <a:off x="3415209" y="1996271"/>
            <a:ext cx="1347292" cy="37343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3" name="Grafik 42">
            <a:extLst>
              <a:ext uri="{FF2B5EF4-FFF2-40B4-BE49-F238E27FC236}">
                <a16:creationId xmlns:a16="http://schemas.microsoft.com/office/drawing/2014/main" id="{877ABF80-8446-4E39-873E-E284D234A56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41" t="51278" r="74244" b="40825"/>
          <a:stretch/>
        </p:blipFill>
        <p:spPr>
          <a:xfrm>
            <a:off x="3415208" y="2579813"/>
            <a:ext cx="1347293" cy="37343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4" name="Grafik 43">
            <a:extLst>
              <a:ext uri="{FF2B5EF4-FFF2-40B4-BE49-F238E27FC236}">
                <a16:creationId xmlns:a16="http://schemas.microsoft.com/office/drawing/2014/main" id="{BD6171E4-0959-40FC-B16B-60EDD2FCC95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840" t="40000" r="38547" b="52062"/>
          <a:stretch/>
        </p:blipFill>
        <p:spPr>
          <a:xfrm>
            <a:off x="5797551" y="4156209"/>
            <a:ext cx="1035050" cy="37343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5" name="Grafik 44">
            <a:extLst>
              <a:ext uri="{FF2B5EF4-FFF2-40B4-BE49-F238E27FC236}">
                <a16:creationId xmlns:a16="http://schemas.microsoft.com/office/drawing/2014/main" id="{96300A07-2A59-453A-BA2E-14F3FF2B10E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819" t="51366" r="38578" b="40825"/>
          <a:stretch/>
        </p:blipFill>
        <p:spPr>
          <a:xfrm>
            <a:off x="5797550" y="4743903"/>
            <a:ext cx="1035049" cy="36927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6" name="Grafik 45">
            <a:extLst>
              <a:ext uri="{FF2B5EF4-FFF2-40B4-BE49-F238E27FC236}">
                <a16:creationId xmlns:a16="http://schemas.microsoft.com/office/drawing/2014/main" id="{98839EDC-447F-4B87-9CF5-9F9B2416823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938" t="40000" r="20450" b="52062"/>
          <a:stretch/>
        </p:blipFill>
        <p:spPr>
          <a:xfrm>
            <a:off x="6804025" y="5242635"/>
            <a:ext cx="1035050" cy="37343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7" name="Grafik 46">
            <a:extLst>
              <a:ext uri="{FF2B5EF4-FFF2-40B4-BE49-F238E27FC236}">
                <a16:creationId xmlns:a16="http://schemas.microsoft.com/office/drawing/2014/main" id="{79E117F6-B9B5-4052-A3CF-88FD3CCBF1D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908" t="51366" r="20489" b="40825"/>
          <a:stretch/>
        </p:blipFill>
        <p:spPr>
          <a:xfrm>
            <a:off x="6804025" y="5830329"/>
            <a:ext cx="1035050" cy="36927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6" name="Grafik 55">
            <a:extLst>
              <a:ext uri="{FF2B5EF4-FFF2-40B4-BE49-F238E27FC236}">
                <a16:creationId xmlns:a16="http://schemas.microsoft.com/office/drawing/2014/main" id="{361DCE45-2CFA-41A5-BA20-653E4255030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0000" r="20449" b="52062"/>
          <a:stretch/>
        </p:blipFill>
        <p:spPr>
          <a:xfrm>
            <a:off x="3415208" y="876179"/>
            <a:ext cx="4423867" cy="37343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7" name="Grafik 56">
            <a:extLst>
              <a:ext uri="{FF2B5EF4-FFF2-40B4-BE49-F238E27FC236}">
                <a16:creationId xmlns:a16="http://schemas.microsoft.com/office/drawing/2014/main" id="{0F72A95B-53EE-479C-B1E6-4F500B03457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1366" r="20489" b="40825"/>
          <a:stretch/>
        </p:blipFill>
        <p:spPr>
          <a:xfrm>
            <a:off x="3415208" y="1463873"/>
            <a:ext cx="4423867" cy="369279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3332237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</Words>
  <Application>Microsoft Office PowerPoint</Application>
  <PresentationFormat>Breitbild</PresentationFormat>
  <Paragraphs>27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tin Müller</dc:creator>
  <cp:lastModifiedBy>Martin Müller</cp:lastModifiedBy>
  <cp:revision>7</cp:revision>
  <dcterms:created xsi:type="dcterms:W3CDTF">2023-03-14T09:44:33Z</dcterms:created>
  <dcterms:modified xsi:type="dcterms:W3CDTF">2023-09-16T11:20:19Z</dcterms:modified>
</cp:coreProperties>
</file>